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200675-A141-447C-BD88-4E302863CC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58BF54-C176-4A55-93F8-395FFE898A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F69CA3-703E-448E-AAFE-083E181B3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BF220-736B-4C1F-AD33-542D788C5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FC2F9F-8388-4B17-B820-E2F018B8F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932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F150D-D9F2-4843-8709-3E4BEAF13B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CB56B1-2691-45EA-A99C-C508FBE73B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1476D2-5A61-43A8-B719-BEFB422E3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ED57C-5AF3-4AA4-A3D9-F8E877DC6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EF85F4-611B-45C6-9820-1BFC0A956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479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9F773B-8B78-404F-903F-0606FCFF11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9D21C3-BDFD-4D26-81F1-78F56DA23D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124355-DB2F-42F5-8168-A2DDB3F8E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72E3C3-9F1C-4AFF-B97E-ABD993191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40B539-3053-4AFE-94B9-D0078A875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61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78DF9-8E90-49A8-877F-40F8DC3E89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8CB08C-F747-4F23-A68D-BA7D8DD0B7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218D96-5FBA-4786-AB34-14DF03200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72E93E-F3BC-4E27-A84C-708A3EA18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CC1850-C01B-4FB2-B89C-3C86C4EBA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469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0C3264-2924-4CAA-9DD1-EDA8C197CB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57C61B-1EB0-4AD4-AB3D-60263420BF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0B5506-374C-4278-BBC1-152B1533D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2195AF-2A38-4531-98A6-2E87E3B8D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B8E5A9-4C0E-4E0C-BC28-9921DF1FF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390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421744-4FA2-42BF-88E8-EC3519F843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40A46-23F0-48B4-B844-3CB11968EC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EAF52A-2EB7-4A32-9FA6-E171F120B7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C3AC46-5E6E-46C5-8069-0D78F1A15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D4F8F8-F802-4D2B-B97A-906410531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87CE-7E84-4B59-860F-9D1FFED7B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600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89CB5C-AE39-4B8F-9CB6-13D2DAE21B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84AB51-0C4A-42F6-9744-6CE31542EA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192C4E-D5ED-4472-880E-8B4139B2CF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855166-F6BB-45F4-A40C-F5A25AB02F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FE0185-525C-4BBE-AB3B-64FCF21D89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ADC927-5A6C-4B21-B204-18984B465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879A53-7D10-4D23-B6C9-56974203D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C27ABB-91AC-4FFE-BB38-D7B851C81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822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35A199-7A66-4143-86ED-508067B91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935CB7-C6B5-4A96-BB10-DA6FD728E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6E5005-0E74-4F17-8587-C4908D45F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4880EF-1393-48D8-9787-B8CF8CC5B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97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E7C653-64D9-4147-9DCF-20CBC5D01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CF66260-1667-4C29-8E78-9374CFEAF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6A2935-37F1-4DBD-B2A6-113D41054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380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A8F52C-410E-49EA-8E63-258FAE0BCF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DF9AFA-6288-4FDD-8A41-3124E5E051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F6A2E7-B670-49A7-A744-298453AE9C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FF7788-5D12-4E9A-9F05-378DCCD2F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9BBEC5-4F97-43EC-9EFD-9E93EECEA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D84258-D5C6-4F0F-B021-354B29F51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04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84CC3-B9F2-4BDE-AD8F-72E5D71D4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99AF74-AFB2-4F00-AF60-766D4CEDF1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0073F9-4560-492B-A8DE-4139910C17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C25F88-3779-4788-9C98-F8893E7B3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4EEE04-9C30-4EB1-AC70-15F333ACC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2E85B-0B8E-4F63-896D-262D8470F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897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1845A9-441A-43A3-ACFA-BFBB8EBCA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3D552D-BA26-439A-AC5B-EE9ADAC00D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967586-D25E-43CC-A8AC-7B84F21D02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3F7472-94F0-46F9-85F9-78142A69EE32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19203-E85C-4E0F-985B-F20E13036B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5521FC-6111-432F-8667-EDC482C8BF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381E4-0D95-483F-8D11-E7B6BD12B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565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1">
                <a:lumMod val="5000"/>
                <a:lumOff val="95000"/>
              </a:schemeClr>
            </a:gs>
            <a:gs pos="74000">
              <a:schemeClr val="accent1">
                <a:lumMod val="45000"/>
                <a:lumOff val="55000"/>
              </a:schemeClr>
            </a:gs>
            <a:gs pos="83000">
              <a:schemeClr val="accent1">
                <a:lumMod val="45000"/>
                <a:lumOff val="55000"/>
              </a:schemeClr>
            </a:gs>
            <a:gs pos="100000">
              <a:schemeClr val="accent1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25F55937-4336-45B4-A534-71D5AB0AB8F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570481" y="314932"/>
            <a:ext cx="7392670" cy="5974412"/>
          </a:xfrm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5657E43B-C02E-452B-A319-C08956A845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1655" y="6289344"/>
            <a:ext cx="11259820" cy="399603"/>
          </a:xfrm>
        </p:spPr>
        <p:txBody>
          <a:bodyPr>
            <a:noAutofit/>
          </a:bodyPr>
          <a:lstStyle/>
          <a:p>
            <a:pPr algn="ctr"/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47 countries in WHO/AFR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icipated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93F3D8F8-A2BB-4142-9189-F9DF9EE21F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5327108"/>
              </p:ext>
            </p:extLst>
          </p:nvPr>
        </p:nvGraphicFramePr>
        <p:xfrm>
          <a:off x="3672840" y="4335304"/>
          <a:ext cx="2184399" cy="368300"/>
        </p:xfrm>
        <a:graphic>
          <a:graphicData uri="http://schemas.openxmlformats.org/drawingml/2006/table">
            <a:tbl>
              <a:tblPr/>
              <a:tblGrid>
                <a:gridCol w="803457">
                  <a:extLst>
                    <a:ext uri="{9D8B030D-6E8A-4147-A177-3AD203B41FA5}">
                      <a16:colId xmlns:a16="http://schemas.microsoft.com/office/drawing/2014/main" val="3273079521"/>
                    </a:ext>
                  </a:extLst>
                </a:gridCol>
                <a:gridCol w="1380942">
                  <a:extLst>
                    <a:ext uri="{9D8B030D-6E8A-4147-A177-3AD203B41FA5}">
                      <a16:colId xmlns:a16="http://schemas.microsoft.com/office/drawing/2014/main" val="666997508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 participant countries 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52813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 of WHO/AFR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40553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78002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2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Figure S1. Map of 47 countries in WHO/AFR that participated in the study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eneral Map</dc:title>
  <dc:creator>IRAGENA, Jean De Dieu</dc:creator>
  <cp:lastModifiedBy>IRAGENA, Jean De Dieu</cp:lastModifiedBy>
  <cp:revision>16</cp:revision>
  <dcterms:created xsi:type="dcterms:W3CDTF">2024-02-25T20:12:32Z</dcterms:created>
  <dcterms:modified xsi:type="dcterms:W3CDTF">2024-03-01T15:24:02Z</dcterms:modified>
</cp:coreProperties>
</file>